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1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dhuravasal Krishnan, Janani (jananimk)" userId="6969b20d-d298-4095-ade9-5a3c5ff7904a" providerId="ADAL" clId="{05E9275C-4D5A-4F41-A620-09F31CF85127}"/>
    <pc:docChg chg="custSel addSld modSld">
      <pc:chgData name="Madhuravasal Krishnan, Janani (jananimk)" userId="6969b20d-d298-4095-ade9-5a3c5ff7904a" providerId="ADAL" clId="{05E9275C-4D5A-4F41-A620-09F31CF85127}" dt="2024-06-12T20:12:59.590" v="98" actId="113"/>
      <pc:docMkLst>
        <pc:docMk/>
      </pc:docMkLst>
      <pc:sldChg chg="addSp delSp modSp add">
        <pc:chgData name="Madhuravasal Krishnan, Janani (jananimk)" userId="6969b20d-d298-4095-ade9-5a3c5ff7904a" providerId="ADAL" clId="{05E9275C-4D5A-4F41-A620-09F31CF85127}" dt="2024-06-12T20:12:59.590" v="98" actId="113"/>
        <pc:sldMkLst>
          <pc:docMk/>
          <pc:sldMk cId="3472543270" sldId="256"/>
        </pc:sldMkLst>
        <pc:spChg chg="del">
          <ac:chgData name="Madhuravasal Krishnan, Janani (jananimk)" userId="6969b20d-d298-4095-ade9-5a3c5ff7904a" providerId="ADAL" clId="{05E9275C-4D5A-4F41-A620-09F31CF85127}" dt="2024-06-03T18:06:22.741" v="1" actId="478"/>
          <ac:spMkLst>
            <pc:docMk/>
            <pc:sldMk cId="3472543270" sldId="256"/>
            <ac:spMk id="2" creationId="{51B00794-A3EB-46AC-BF28-B74EEFEBFF17}"/>
          </ac:spMkLst>
        </pc:spChg>
        <pc:spChg chg="del">
          <ac:chgData name="Madhuravasal Krishnan, Janani (jananimk)" userId="6969b20d-d298-4095-ade9-5a3c5ff7904a" providerId="ADAL" clId="{05E9275C-4D5A-4F41-A620-09F31CF85127}" dt="2024-06-03T18:06:22.741" v="1" actId="478"/>
          <ac:spMkLst>
            <pc:docMk/>
            <pc:sldMk cId="3472543270" sldId="256"/>
            <ac:spMk id="3" creationId="{B7CDCEDA-48BF-4050-B212-DB8C0BA456E6}"/>
          </ac:spMkLst>
        </pc:spChg>
        <pc:spChg chg="add mod">
          <ac:chgData name="Madhuravasal Krishnan, Janani (jananimk)" userId="6969b20d-d298-4095-ade9-5a3c5ff7904a" providerId="ADAL" clId="{05E9275C-4D5A-4F41-A620-09F31CF85127}" dt="2024-06-12T20:12:59.590" v="98" actId="113"/>
          <ac:spMkLst>
            <pc:docMk/>
            <pc:sldMk cId="3472543270" sldId="256"/>
            <ac:spMk id="6" creationId="{031B7B8E-A534-4943-927F-0B96E1222487}"/>
          </ac:spMkLst>
        </pc:spChg>
        <pc:picChg chg="add del mod modCrop">
          <ac:chgData name="Madhuravasal Krishnan, Janani (jananimk)" userId="6969b20d-d298-4095-ade9-5a3c5ff7904a" providerId="ADAL" clId="{05E9275C-4D5A-4F41-A620-09F31CF85127}" dt="2024-06-03T18:08:02.204" v="17" actId="478"/>
          <ac:picMkLst>
            <pc:docMk/>
            <pc:sldMk cId="3472543270" sldId="256"/>
            <ac:picMk id="4" creationId="{A75B7B20-76E8-47FE-A5E1-0737232B87DB}"/>
          </ac:picMkLst>
        </pc:picChg>
        <pc:picChg chg="add mod modCrop">
          <ac:chgData name="Madhuravasal Krishnan, Janani (jananimk)" userId="6969b20d-d298-4095-ade9-5a3c5ff7904a" providerId="ADAL" clId="{05E9275C-4D5A-4F41-A620-09F31CF85127}" dt="2024-06-03T18:08:32.708" v="25" actId="1076"/>
          <ac:picMkLst>
            <pc:docMk/>
            <pc:sldMk cId="3472543270" sldId="256"/>
            <ac:picMk id="5" creationId="{6F841E82-6A65-4D5E-86C5-E52200BD619A}"/>
          </ac:picMkLst>
        </pc:picChg>
      </pc:sldChg>
    </pc:docChg>
  </pc:docChgLst>
  <pc:docChgLst>
    <pc:chgData name="Madhuravasal Krishnan, Janani (jananimk)" userId="6969b20d-d298-4095-ade9-5a3c5ff7904a" providerId="ADAL" clId="{1A492861-89FB-4FF6-BCF6-A0E8AEF2A68F}"/>
    <pc:docChg chg="modSld">
      <pc:chgData name="Madhuravasal Krishnan, Janani (jananimk)" userId="6969b20d-d298-4095-ade9-5a3c5ff7904a" providerId="ADAL" clId="{1A492861-89FB-4FF6-BCF6-A0E8AEF2A68F}" dt="2024-07-11T18:38:52.631" v="21" actId="1035"/>
      <pc:docMkLst>
        <pc:docMk/>
      </pc:docMkLst>
      <pc:sldChg chg="modSp">
        <pc:chgData name="Madhuravasal Krishnan, Janani (jananimk)" userId="6969b20d-d298-4095-ade9-5a3c5ff7904a" providerId="ADAL" clId="{1A492861-89FB-4FF6-BCF6-A0E8AEF2A68F}" dt="2024-07-11T18:38:52.631" v="21" actId="1035"/>
        <pc:sldMkLst>
          <pc:docMk/>
          <pc:sldMk cId="3472543270" sldId="256"/>
        </pc:sldMkLst>
        <pc:spChg chg="mod">
          <ac:chgData name="Madhuravasal Krishnan, Janani (jananimk)" userId="6969b20d-d298-4095-ade9-5a3c5ff7904a" providerId="ADAL" clId="{1A492861-89FB-4FF6-BCF6-A0E8AEF2A68F}" dt="2024-07-11T18:38:41" v="17" actId="1036"/>
          <ac:spMkLst>
            <pc:docMk/>
            <pc:sldMk cId="3472543270" sldId="256"/>
            <ac:spMk id="6" creationId="{031B7B8E-A534-4943-927F-0B96E1222487}"/>
          </ac:spMkLst>
        </pc:spChg>
        <pc:picChg chg="mod">
          <ac:chgData name="Madhuravasal Krishnan, Janani (jananimk)" userId="6969b20d-d298-4095-ade9-5a3c5ff7904a" providerId="ADAL" clId="{1A492861-89FB-4FF6-BCF6-A0E8AEF2A68F}" dt="2024-07-11T18:38:52.631" v="21" actId="1035"/>
          <ac:picMkLst>
            <pc:docMk/>
            <pc:sldMk cId="3472543270" sldId="256"/>
            <ac:picMk id="5" creationId="{6F841E82-6A65-4D5E-86C5-E52200BD619A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00D59E-24B9-4B17-90DB-2FD94CFB0D19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9D689B-D3C5-433F-A34D-EF1BB27E91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198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9D689B-D3C5-433F-A34D-EF1BB27E916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6643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75EAE9-505A-4F57-B92F-7A10B18D51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A3D9F6C-9B16-4240-87AC-A2BCB64622C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E1575E-B405-4FAC-874F-F6DBF01BDB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EC4D2-F4C1-4D07-B77B-5D2654D31AD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5D5F0D-E519-43DE-9867-6661455A03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F28877-BC08-4783-88ED-30B5198EC9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71350-AAF7-4FD8-99D6-8774B1AAEB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7961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5E6D3B-1005-4765-8E37-B2CE9D9F86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054A0B-8B60-4393-BDBF-AF577AAB5A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B217D8-AF6D-4E09-90E2-FD1C51DF3A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EC4D2-F4C1-4D07-B77B-5D2654D31AD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3B0D4B-F775-442C-AFEA-94A178EE7F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E894F7-D9E4-4682-9EAA-B59EA5E9E5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71350-AAF7-4FD8-99D6-8774B1AAEB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504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5440A26-E3DE-4800-BA03-5CFFDE9CAA5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BE17D03-1082-439B-8B54-66D283E55E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97523D-ADD7-43E4-8120-712B8D7AE7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EC4D2-F4C1-4D07-B77B-5D2654D31AD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EC0135-EC51-4CBF-B68D-F385CF820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A63AC8-EDDC-44EF-B692-E057F68B76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71350-AAF7-4FD8-99D6-8774B1AAEB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6714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162B20-A756-4D06-8650-6CB622D4CB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B9A416-5E5D-4ECA-990C-94AB3F71A90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6F4548-1064-48B8-8BF3-0AF6E231AB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EC4D2-F4C1-4D07-B77B-5D2654D31AD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EB5687-F6DF-4054-80D3-F5AF8C3B41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316E70-9C34-4D40-A33B-9A78EEF543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71350-AAF7-4FD8-99D6-8774B1AAEB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8943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51FF64-4C55-4932-A7C0-F2221F420A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AF49C6-A376-4E21-8FEE-CA6539BB8E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0C03FE-F47D-4885-B891-17D2E85075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EC4D2-F4C1-4D07-B77B-5D2654D31AD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9B48D9-A81C-428B-8C31-EAAC286113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1BC332-5891-4C81-9322-9AE72EB6A8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71350-AAF7-4FD8-99D6-8774B1AAEB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374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96A8AF-CF01-483F-A011-55948EFAF1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C9EB90-F239-4650-BDB6-8758C6C28F3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92A76F-8743-4D93-A243-E70DE09EF3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AA33E5-F4FC-45FC-B5E9-6A440A65D6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EC4D2-F4C1-4D07-B77B-5D2654D31AD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25ADE4-8127-4214-A0B2-4304B8A8FF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1A9DB7-0033-40EE-8F70-A9AC168CE1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71350-AAF7-4FD8-99D6-8774B1AAEB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0374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466282-6F29-436D-A740-F1BD31D7BB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0B0A1F-FD30-4904-BD99-022EE4B988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601D15C-4ED0-4979-9B92-8F1DD87848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5F18B9B-256D-4F96-8764-8DB2AFCC089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8943423-08A4-4E51-90F6-79C3C8410EA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283C7BB-B4AF-4849-90E6-82D65EA502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EC4D2-F4C1-4D07-B77B-5D2654D31AD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1A6A52C-51D3-4E90-90B6-79CD28DAEF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1ABD1AC-8D2D-49DA-BA50-85F56F8473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71350-AAF7-4FD8-99D6-8774B1AAEB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7960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4F917A-E984-473F-881D-548B55E06A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ADA8A5D-B481-4D93-95F1-2E7E6654FE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EC4D2-F4C1-4D07-B77B-5D2654D31AD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2C01C92-CBD3-4C7D-94A5-D0F42E403E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CC85593-25B5-47E3-9694-E1EB14C42C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71350-AAF7-4FD8-99D6-8774B1AAEB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9599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11D0DF6-A816-481A-8CC0-BE1F2F447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EC4D2-F4C1-4D07-B77B-5D2654D31AD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FB5FE00-6B2D-484B-B27E-D5CD5A2D77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4A7EF49-4709-4912-A2B9-273215AC2B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71350-AAF7-4FD8-99D6-8774B1AAEB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9464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2507F7-E772-4E90-B3BE-5B55CC472C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1A21E3-A64C-49F7-963B-513F39FF83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CD5A65-1A56-4DB8-9A7D-5546FD49F8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10E386-09F3-46EA-874E-812BE8754A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EC4D2-F4C1-4D07-B77B-5D2654D31AD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F1F30B-8DBB-4514-A481-340AEE5244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B5025C-9E87-41E5-B1F0-6555320A94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71350-AAF7-4FD8-99D6-8774B1AAEB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857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9CD2E5-5815-4C57-B6DC-D65BFB8AA3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8F51C7C-2B95-495A-9DA3-19B2080D67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FFB0E10-840E-4563-8855-7209EBC8B3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1B5BDB-98BD-44E1-9D11-421F6FC5E4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EC4D2-F4C1-4D07-B77B-5D2654D31AD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CC53C1-49AA-479F-8CC7-E251081468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CA8BAA-ECDF-420C-8E34-D20E790F8B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71350-AAF7-4FD8-99D6-8774B1AAEB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4304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52AC09D-4CD7-43CC-8FB7-AD6F1800EA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3FB707-4D22-42EC-B215-536968BB7A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0BA5EC-1ABF-481E-B9C4-0B2F43D5DC1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1EC4D2-F4C1-4D07-B77B-5D2654D31ADF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35616C-6336-4987-95F9-F8020FD3A03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B57304-3538-478D-979A-4E03D3BA939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B71350-AAF7-4FD8-99D6-8774B1AAEB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5512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F841E82-6A65-4D5E-86C5-E52200BD619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1631" t="11401" r="33804" b="63092"/>
          <a:stretch/>
        </p:blipFill>
        <p:spPr>
          <a:xfrm>
            <a:off x="680764" y="1494050"/>
            <a:ext cx="10388938" cy="431239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31B7B8E-A534-4943-927F-0B96E1222487}"/>
              </a:ext>
            </a:extLst>
          </p:cNvPr>
          <p:cNvSpPr txBox="1"/>
          <p:nvPr/>
        </p:nvSpPr>
        <p:spPr>
          <a:xfrm>
            <a:off x="0" y="6585103"/>
            <a:ext cx="1219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</a:rPr>
              <a:t>Supplementary figure 6</a:t>
            </a:r>
            <a:r>
              <a:rPr lang="en-US" sz="1200" dirty="0">
                <a:latin typeface="Times New Roman" panose="02020603050405020304" pitchFamily="18" charset="0"/>
              </a:rPr>
              <a:t>: percentage of cell subsets </a:t>
            </a:r>
            <a:r>
              <a:rPr lang="en-US" sz="1200" dirty="0">
                <a:solidFill>
                  <a:srgbClr val="11111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r each conditions, PBMC control, PBMC infected with HIV in the presence or absence of fentanyl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4725432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27</Words>
  <Application>Microsoft Office PowerPoint</Application>
  <PresentationFormat>Widescreen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dhuravasal Krishnan, Janani (jananimk)</dc:creator>
  <cp:lastModifiedBy>Madhuravasal Krishnan, Janani (jananimk)</cp:lastModifiedBy>
  <cp:revision>2</cp:revision>
  <dcterms:created xsi:type="dcterms:W3CDTF">2024-06-03T18:06:19Z</dcterms:created>
  <dcterms:modified xsi:type="dcterms:W3CDTF">2024-07-11T18:38:59Z</dcterms:modified>
</cp:coreProperties>
</file>